
<file path=[Content_Types].xml><?xml version="1.0" encoding="utf-8"?>
<Types xmlns="http://schemas.openxmlformats.org/package/2006/content-types">
  <Default Extension="wmf" ContentType="image/x-wmf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0413" cy="6858000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594" y="102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2413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2413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7DBEB3E-AACC-481F-A044-F101C4A4D97B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94232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A43C30D-B887-4815-89CD-6C07B5B35E5A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1060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839200" y="274638"/>
            <a:ext cx="2741613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609600" y="274638"/>
            <a:ext cx="80772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A5DC1E4-330A-40D6-83BF-B830DF2542E1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9885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CE8D64-404A-4D57-8DD7-969DEB445CF1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80279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4013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4013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652456-2B3E-4025-AB26-9CB9759A1837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678468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609600" y="1600200"/>
            <a:ext cx="5408613" cy="452596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0613" y="1600200"/>
            <a:ext cx="5410200" cy="452596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885CA4-8E06-40B8-A419-28730709180E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138857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4012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0613" y="1681163"/>
            <a:ext cx="51831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0613" y="2505075"/>
            <a:ext cx="51831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6EFBEC5-0939-4321-B548-669FA2A11E4E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4605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F138BA6-67D7-4EEE-900A-DDFFADEA6BA3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019702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0DA2C74-AC43-4615-90A3-B635EE7FEF13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98929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0612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1BB9394-43D5-45F1-92A2-2AEE429F71BC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19058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0612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E1DA65-F262-4124-98CF-1E59D336EB4F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54486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1213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0"/>
            <a:ext cx="10971213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59213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6013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04BA04F1-0A02-45DE-AC9E-4DBD7FA56B24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/>
        </p:nvSpPr>
        <p:spPr>
          <a:xfrm>
            <a:off x="1486694" y="5373216"/>
            <a:ext cx="8780810" cy="923330"/>
          </a:xfrm>
          <a:prstGeom prst="rect">
            <a:avLst/>
          </a:prstGeom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50000"/>
              </a:lnSpc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Length distribution of small RNA. </a:t>
            </a:r>
            <a:r>
              <a:rPr lang="en-US" altLang="zh-TW" dirty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Summary of the frequency of </a:t>
            </a:r>
            <a:r>
              <a:rPr lang="en-US" altLang="zh-CN" dirty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 small RNA size </a:t>
            </a:r>
            <a:r>
              <a:rPr lang="en-US" altLang="zh-TW" dirty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in control (white bar) and +P-</a:t>
            </a:r>
            <a:r>
              <a:rPr lang="en-US" altLang="zh-TW" dirty="0" err="1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indica</a:t>
            </a:r>
            <a:r>
              <a:rPr lang="en-US" altLang="zh-TW" dirty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 (dark bar).</a:t>
            </a:r>
            <a:endParaRPr lang="zh-TW" altLang="zh-TW" dirty="0">
              <a:latin typeface="Times New Roman" panose="02020603050405020304" pitchFamily="18" charset="0"/>
              <a:ea typeface="Arial Unicode MS" panose="020B0604020202020204" pitchFamily="34" charset="-120"/>
              <a:cs typeface="Times New Roman" panose="02020603050405020304" pitchFamily="18" charset="0"/>
            </a:endParaRPr>
          </a:p>
        </p:txBody>
      </p:sp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614" y="404664"/>
            <a:ext cx="10058400" cy="4870868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ea typeface="宋体" panose="02010600030101010101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ea typeface="宋体" panose="02010600030101010101" pitchFamily="2" charset="-122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0</Words>
  <Application>Microsoft Office PowerPoint</Application>
  <PresentationFormat>自訂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Arial</vt:lpstr>
      <vt:lpstr>宋体</vt:lpstr>
      <vt:lpstr>Times New Roman</vt:lpstr>
      <vt:lpstr>Arial Unicode MS</vt:lpstr>
      <vt:lpstr>默认设计模板</vt:lpstr>
      <vt:lpstr>PowerPoint 簡報</vt:lpstr>
    </vt:vector>
  </TitlesOfParts>
  <Company>Lenov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 User</dc:creator>
  <cp:lastModifiedBy>水月</cp:lastModifiedBy>
  <cp:revision>4</cp:revision>
  <dcterms:created xsi:type="dcterms:W3CDTF">2013-09-23T15:00:42Z</dcterms:created>
  <dcterms:modified xsi:type="dcterms:W3CDTF">2013-10-01T14:42:13Z</dcterms:modified>
</cp:coreProperties>
</file>